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3"/>
    <p:restoredTop sz="94693"/>
  </p:normalViewPr>
  <p:slideViewPr>
    <p:cSldViewPr snapToGrid="0" snapToObjects="1">
      <p:cViewPr varScale="1">
        <p:scale>
          <a:sx n="78" d="100"/>
          <a:sy n="78" d="100"/>
        </p:scale>
        <p:origin x="2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292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58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805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1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32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7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520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680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948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854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589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679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:\Users\Angela\Documents\NYC\Sussel Lab\EPKO\EPKO Paper Figures\Supp Table 5_Page_1.tif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3" t="7372" r="70644" b="8804"/>
          <a:stretch/>
        </p:blipFill>
        <p:spPr bwMode="auto">
          <a:xfrm>
            <a:off x="907407" y="1311797"/>
            <a:ext cx="2419350" cy="6515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 descr="C:\Users\Angela\Documents\NYC\Sussel Lab\EPKO\EPKO Paper Figures\Supp Table 5_Page_2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3" t="7598" r="70833" b="21569"/>
          <a:stretch/>
        </p:blipFill>
        <p:spPr bwMode="auto">
          <a:xfrm>
            <a:off x="3326757" y="2321447"/>
            <a:ext cx="2400300" cy="5505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618040" y="303437"/>
            <a:ext cx="5429250" cy="6924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B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4.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 bound and regulated genes that are also Rfx6 bound and NeuroD1 bound (72 genes).</a:t>
            </a:r>
          </a:p>
        </p:txBody>
      </p:sp>
    </p:spTree>
    <p:extLst>
      <p:ext uri="{BB962C8B-B14F-4D97-AF65-F5344CB8AC3E}">
        <p14:creationId xmlns:p14="http://schemas.microsoft.com/office/powerpoint/2010/main" val="806067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6-08-03T22:47:30Z</dcterms:created>
  <dcterms:modified xsi:type="dcterms:W3CDTF">2016-08-04T16:58:16Z</dcterms:modified>
</cp:coreProperties>
</file>